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6327"/>
  </p:normalViewPr>
  <p:slideViewPr>
    <p:cSldViewPr snapToGrid="0" snapToObjects="1">
      <p:cViewPr varScale="1">
        <p:scale>
          <a:sx n="110" d="100"/>
          <a:sy n="110" d="100"/>
        </p:scale>
        <p:origin x="11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9048E-7EA3-CD40-AF3F-98E64AA26C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56599E-0AFA-6741-BC88-B3200E6311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679EE-B2A8-564A-B837-1C501FF16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E6432-194B-1E4D-9F6A-35A9CF0F0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A98919-F31B-9E47-BEBA-A2F4C3774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184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48176-FD39-B24B-BBA9-1E25A7040C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419052-D0B1-3D43-A4F3-1AC5A8435D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F84964-A474-324B-9C8F-CED681AAE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60F7B7-069B-2E46-B2BD-2425BE7A0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458E6-DFCE-3A49-B6BF-E73F20B7C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71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FC9860-7C5D-A346-87E9-3D3E53A21F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E78889-F034-0640-AD04-E007DFFE0D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689C45-E727-294A-8D74-5C482C679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CA9DE2-683E-8E40-A2B5-FF9A96DEC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E64BB9-A3E6-514F-9C47-69BE91F0A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357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8988D-4EB8-724B-BEDD-27BE3AEC3F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00D937-8B2A-074F-8391-E0B9AAF124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E59031-DAFF-E24A-9487-796DBCB09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6FA14-ACF2-6846-849D-C531F04E8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17CA7-9308-C442-AF3D-CFF296FDE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97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FF4174-1270-A547-A497-AF34DACDE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F881ED-109E-C048-80AF-48866715F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312583-7E60-B341-8F46-9C99F82C4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3274AF-8968-C44A-A977-CB0841417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BBDC2A-82B4-C145-BBC6-48895E083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400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D9A959-269F-2441-B221-B360D403EA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9548E6-B347-CA49-94E6-44F36085C5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FB8904-ED37-DD47-B072-700E166AFD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0B91E5-CA45-2545-95B5-5DFDBDA26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AF2FF8-D885-0A47-9ED4-BAE89AE70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C2F0DB-07DA-F44F-B376-E97C463D2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021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27A8B0-B9AB-AA48-BDA3-3CFA3D3F4C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2AD6DA-737A-1B45-B6BC-79D358A6F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540150-AF4F-3C44-B51E-202E3552B7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96578F-48A7-7746-80CE-712FDBD252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552C00-00B9-304B-A3BE-7961CFD419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D53C3F-FA8B-6E4E-804A-2DBBAA0A1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1F3BD5-E004-9245-A161-9B74B2BBE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536C59-6086-F943-8DC2-B199AED35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759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A4FC4-A27B-174A-A0F7-6EAD6B293F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657DE9-BFCB-C449-8696-439372DA2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59C322-0BC7-244C-BC80-445C0A548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A865F4-B530-E649-8E0F-1C985D484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583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B4DCF6-3970-AD45-AE95-4BC2A6F7E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18DC25-D21E-EF4D-A99E-C60C11FB0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17AE06-D8D2-D843-AB4F-94AB5EE9D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547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8523C-B686-544C-BB12-F99D63197C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E030D2-D068-4649-B4C0-6A74F9E6AC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A62AD7-79FB-414A-B9F4-702270AF1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4FB929-9F9B-D542-9FD8-E180D8AC4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ED8766-94FC-ED44-A5CF-3ED1137E6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F50A63-279D-AC4C-8134-845F85CD0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086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A8890-9AFB-574A-AC7E-030492236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716757-6F71-BC43-AB52-D74A22C532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EDD4BF-DB5B-5140-A6B0-21B48280F0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E565A5-0C45-CE46-B17B-15FDF2501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597B22-AE6D-3247-B5C5-1CAF1CA03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665F95-FBC0-F644-9B51-610DF2B13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09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EA40C3-C10F-4147-81CC-1D04C9768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3E59ED-2E85-8540-8EB2-BD04D5B300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182A96-A5E0-CD4D-8643-8F8D53E2CF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D0BBF1-3AA8-8942-9E1D-498E4EB4ED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EAC3C-1750-F14E-850F-EE9E4DF34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04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>
            <a:extLst>
              <a:ext uri="{FF2B5EF4-FFF2-40B4-BE49-F238E27FC236}">
                <a16:creationId xmlns:a16="http://schemas.microsoft.com/office/drawing/2014/main" id="{8996523B-6973-9F4E-A0F4-87488C75BB7A}"/>
              </a:ext>
            </a:extLst>
          </p:cNvPr>
          <p:cNvSpPr/>
          <p:nvPr/>
        </p:nvSpPr>
        <p:spPr>
          <a:xfrm>
            <a:off x="5583182" y="302094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G" sz="1159" b="1" dirty="0"/>
              <a:t>t0</a:t>
            </a:r>
            <a:endParaRPr lang="en-BG" sz="1159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7D2FCFC-5385-3F41-A5D2-A63CE425B48F}"/>
              </a:ext>
            </a:extLst>
          </p:cNvPr>
          <p:cNvSpPr/>
          <p:nvPr/>
        </p:nvSpPr>
        <p:spPr>
          <a:xfrm>
            <a:off x="8791348" y="302094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G" sz="1159" b="1" dirty="0"/>
              <a:t>t12</a:t>
            </a:r>
            <a:endParaRPr lang="en-BG" sz="1159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3E6EE1D-8182-A84C-A216-691A005F9930}"/>
              </a:ext>
            </a:extLst>
          </p:cNvPr>
          <p:cNvSpPr/>
          <p:nvPr/>
        </p:nvSpPr>
        <p:spPr>
          <a:xfrm>
            <a:off x="5583182" y="3361485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9" b="1" dirty="0"/>
              <a:t>t</a:t>
            </a:r>
            <a:r>
              <a:rPr lang="en-BG" sz="1159" b="1" dirty="0"/>
              <a:t>48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CE25931A-E707-1B49-947A-A8924128003A}"/>
              </a:ext>
            </a:extLst>
          </p:cNvPr>
          <p:cNvSpPr/>
          <p:nvPr/>
        </p:nvSpPr>
        <p:spPr>
          <a:xfrm>
            <a:off x="8791348" y="3361485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9" b="1" dirty="0"/>
              <a:t>t</a:t>
            </a:r>
            <a:r>
              <a:rPr lang="en-BG" sz="1159" b="1" dirty="0"/>
              <a:t>9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563D9BC-9CC6-7248-913E-B1234A62A256}"/>
              </a:ext>
            </a:extLst>
          </p:cNvPr>
          <p:cNvSpPr txBox="1"/>
          <p:nvPr/>
        </p:nvSpPr>
        <p:spPr>
          <a:xfrm>
            <a:off x="718476" y="4407459"/>
            <a:ext cx="398052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upplementary Figure </a:t>
            </a:r>
            <a:r>
              <a:rPr lang="en-US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2</a:t>
            </a:r>
            <a:r>
              <a:rPr lang="en-BG" sz="1400" b="1">
                <a:latin typeface="Arial Narrow" panose="020B0604020202020204" pitchFamily="34" charset="0"/>
                <a:cs typeface="Arial Narrow" panose="020B0604020202020204" pitchFamily="34" charset="0"/>
              </a:rPr>
              <a:t>. </a:t>
            </a:r>
            <a:r>
              <a:rPr lang="en-US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Two-dimensional UMAP projections of the scRNA-seq data from the 4 time-points after MCF7 drug treatment for assessment of batch and cell-cycle effects. a) No batch effects are seen in the combined t0-t96 UMAP projection. b) Cell cycle scores computed for the 4 time-points after MCF7 drug based on expression of G2/M and S phase markers assigned using Seurat after regressing out the cell cycle source of heterogeneity. </a:t>
            </a:r>
          </a:p>
        </p:txBody>
      </p:sp>
      <p:pic>
        <p:nvPicPr>
          <p:cNvPr id="59" name="Picture 58" descr="Chart, scatter chart&#10;&#10;Description automatically generated">
            <a:extLst>
              <a:ext uri="{FF2B5EF4-FFF2-40B4-BE49-F238E27FC236}">
                <a16:creationId xmlns:a16="http://schemas.microsoft.com/office/drawing/2014/main" id="{E662043E-2A6E-294B-9588-9F55A8E294B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682"/>
          <a:stretch/>
        </p:blipFill>
        <p:spPr>
          <a:xfrm>
            <a:off x="463368" y="572809"/>
            <a:ext cx="3880032" cy="3218449"/>
          </a:xfrm>
          <a:prstGeom prst="rect">
            <a:avLst/>
          </a:prstGeom>
        </p:spPr>
      </p:pic>
      <p:sp>
        <p:nvSpPr>
          <p:cNvPr id="60" name="Rectangle 59">
            <a:extLst>
              <a:ext uri="{FF2B5EF4-FFF2-40B4-BE49-F238E27FC236}">
                <a16:creationId xmlns:a16="http://schemas.microsoft.com/office/drawing/2014/main" id="{469BF993-2275-AF47-A2ED-1D1891E238E0}"/>
              </a:ext>
            </a:extLst>
          </p:cNvPr>
          <p:cNvSpPr/>
          <p:nvPr/>
        </p:nvSpPr>
        <p:spPr>
          <a:xfrm>
            <a:off x="718476" y="115935"/>
            <a:ext cx="53118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a</a:t>
            </a:r>
            <a:endParaRPr lang="en-BG" sz="1600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B1F42D67-44AA-9749-AE7C-A67D58E56C2E}"/>
              </a:ext>
            </a:extLst>
          </p:cNvPr>
          <p:cNvSpPr/>
          <p:nvPr/>
        </p:nvSpPr>
        <p:spPr>
          <a:xfrm>
            <a:off x="5198781" y="115935"/>
            <a:ext cx="30031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b</a:t>
            </a:r>
            <a:endParaRPr lang="en-BG" sz="1600" dirty="0"/>
          </a:p>
        </p:txBody>
      </p:sp>
      <p:pic>
        <p:nvPicPr>
          <p:cNvPr id="63" name="Picture 62" descr="Chart, scatter chart&#10;&#10;Description automatically generated">
            <a:extLst>
              <a:ext uri="{FF2B5EF4-FFF2-40B4-BE49-F238E27FC236}">
                <a16:creationId xmlns:a16="http://schemas.microsoft.com/office/drawing/2014/main" id="{D0FF7FFA-135D-3A4E-9F28-272EFA9D729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082"/>
          <a:stretch/>
        </p:blipFill>
        <p:spPr>
          <a:xfrm>
            <a:off x="5499100" y="749299"/>
            <a:ext cx="2957339" cy="2468880"/>
          </a:xfrm>
          <a:prstGeom prst="rect">
            <a:avLst/>
          </a:prstGeom>
        </p:spPr>
      </p:pic>
      <p:pic>
        <p:nvPicPr>
          <p:cNvPr id="65" name="Picture 64" descr="Chart, scatter chart&#10;&#10;Description automatically generated">
            <a:extLst>
              <a:ext uri="{FF2B5EF4-FFF2-40B4-BE49-F238E27FC236}">
                <a16:creationId xmlns:a16="http://schemas.microsoft.com/office/drawing/2014/main" id="{61EFF447-3DAB-0B45-B0B7-CDB5EE3CBAA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500"/>
          <a:stretch/>
        </p:blipFill>
        <p:spPr>
          <a:xfrm>
            <a:off x="8830120" y="749298"/>
            <a:ext cx="2970578" cy="246888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70250DFD-EA2E-724A-B8B4-52FC55A86CF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6250"/>
          <a:stretch/>
        </p:blipFill>
        <p:spPr>
          <a:xfrm>
            <a:off x="5583182" y="3791257"/>
            <a:ext cx="2962656" cy="246888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23B104CC-96A9-684B-B25C-840CE1E73EC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6236"/>
          <a:stretch/>
        </p:blipFill>
        <p:spPr>
          <a:xfrm>
            <a:off x="8791348" y="3791258"/>
            <a:ext cx="2962210" cy="2468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384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86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rvath, Anelia Dafinova</dc:creator>
  <cp:lastModifiedBy>Horvath, Anelia Dafinova</cp:lastModifiedBy>
  <cp:revision>12</cp:revision>
  <dcterms:created xsi:type="dcterms:W3CDTF">2021-06-11T17:52:30Z</dcterms:created>
  <dcterms:modified xsi:type="dcterms:W3CDTF">2021-09-26T13:22:16Z</dcterms:modified>
</cp:coreProperties>
</file>